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96866" autoAdjust="0"/>
  </p:normalViewPr>
  <p:slideViewPr>
    <p:cSldViewPr snapToGrid="0">
      <p:cViewPr varScale="1">
        <p:scale>
          <a:sx n="87" d="100"/>
          <a:sy n="87" d="100"/>
        </p:scale>
        <p:origin x="6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DD6BB0-6389-0BF1-409F-11D3CC6EF2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D21DCBC-C2EA-4B82-AC10-3CE6A85D86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226092-F8D3-E027-3161-ED3ECC950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09D4FF-6FA5-DA12-455C-E40EC1DA7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D30AF8-4332-5EC9-6AF6-CCC85A5C5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6422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B24B98-D481-3292-2061-427A3F500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2BB4D66-90D5-E897-5D47-756456453B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837A8F-3E61-4246-9AB7-D7775C51E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2F1D2E-ADD4-CC67-9823-FD95C262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3E1BEC-F5AB-6AA7-24B1-5F21EC085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438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7CF252E-95BC-DF88-1423-FB7BDE0418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1AD8475-4929-CDF6-5BC3-4760BBCFEA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2737A6-23E3-51E3-FBBF-E2FF99392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0C1A60-95FB-3FD7-94DF-261B82951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CEEEB27-8B29-A3EC-734C-81F7E2803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9327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9DB611-F80D-C2E6-9266-E8BAB9CDA9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216998-6A5F-1AD2-B2AF-74E4B06A73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0B6A55-AE0F-CCD8-D2C3-C80ACC3A5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F4613EB-1838-0851-6776-74A059448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06F2EF-D5B1-9DEF-7141-F5A950C65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649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B6DEA4-F15E-5D23-B751-1949595B3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441237-32FF-E7A0-DB28-6C78CACFE8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FF1F580-D813-EA75-146A-5E819564D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ACDA32-7592-111F-0F02-8D29C3248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0733EA8-70FA-C4ED-26B7-91AD36E11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576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ACED501-8E52-3BB3-545C-610CFEF3D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0323B12-795C-7AAB-1112-43E45A45C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E1216E3-9908-391E-865B-F989192799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2E44A6C-F39B-712C-9900-F524A54FA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F6692CD-E4D8-8B16-4B95-84F5E52FB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5922F0C-8B14-D5BB-3F48-CDBC90983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5955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22EF17-40AA-89E7-2711-E29692AFF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1FD33F8-580F-C397-D6FB-858AE4D97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4E6B1D3-942D-65BB-3738-4188B1C2F8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3E124FC-F9D1-5575-A7E1-E97377EB09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2FE1A26-0BF5-70A4-FD63-47295E7466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424F6B9-A8CE-A17C-CB0F-F996263B3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ACFE8D6-DAF6-2374-AB3F-5B24C53D5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A05C7E7-E8B4-1719-E868-82B1023F2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901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ABC102-7894-6AC2-7C63-0EBD89B009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FB3E9FE-E869-E34C-4AFA-F1E8A6703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BDD2D1B-B63A-AA1D-33AE-46CD98737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649DCD1-0261-3739-17DE-F930F221D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826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9D2A119-08F9-597A-AF12-E49F865FF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1100E02-7195-D142-C1B7-EC3AE26EA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9DC6580-A49A-7C80-57F8-EB2B8168F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810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90B2A5-1D96-2BC2-334A-921DB6A82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9877CDE-9E5E-48FC-7688-4AA395405A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FC66023-90E9-8086-202E-54CEAF898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FEC290-80C0-AFC8-E41D-BF8CF801C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9A93779-A6C7-86E7-5895-AF5907B3E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6666EA4-6B53-535C-D7C5-944887030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063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5DCD79-C6C8-1057-AD1D-9ADA961BB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0E513C4-F98E-C664-D4B5-7190E6F331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14F0017-29AB-364E-D52C-CC860F9AA1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4D43340-9E74-D37B-CE08-6211840D3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F54A728-964D-02DC-E11C-432C0CE3A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7392E2B-7E61-D83C-A3B6-88D528E11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847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6A27737-528A-E1A6-EABC-C121FA700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9743D47-1DBA-B9A3-9758-530041C60F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000E22-A0E9-22FF-2A91-E0CCF5BA94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2C9074-BE9C-2FAD-68BD-F7FA71BC8E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D53F51-1FF8-FC20-8FB3-DA89E859B1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5465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 descr="Une image contenant noir et blanc, Photographie monochrome, monochrome, noir&#10;&#10;Description générée automatiquement">
            <a:extLst>
              <a:ext uri="{FF2B5EF4-FFF2-40B4-BE49-F238E27FC236}">
                <a16:creationId xmlns:a16="http://schemas.microsoft.com/office/drawing/2014/main" id="{557B2100-B1A9-9314-B9D1-7FE8212D211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80532" y="564836"/>
            <a:ext cx="5731510" cy="4893945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89DD55D7-2ACC-C51A-6590-316B53EABE95}"/>
              </a:ext>
            </a:extLst>
          </p:cNvPr>
          <p:cNvSpPr txBox="1"/>
          <p:nvPr/>
        </p:nvSpPr>
        <p:spPr>
          <a:xfrm>
            <a:off x="6624349" y="2087292"/>
            <a:ext cx="4824000" cy="1849032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l 3. </a:t>
            </a:r>
            <a:r>
              <a:rPr lang="fr-FR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l </a:t>
            </a:r>
            <a:r>
              <a:rPr lang="en-GB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played in </a:t>
            </a:r>
            <a:r>
              <a:rPr lang="en-GB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GB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gure S3. Wells A, B and C contain non-floated PC:NTA-Ni, PC:</a:t>
            </a:r>
            <a:r>
              <a:rPr lang="en-GB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5:NTA-Ni </a:t>
            </a:r>
            <a:r>
              <a:rPr lang="en-GB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PC:</a:t>
            </a:r>
            <a:r>
              <a:rPr lang="en-GB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20:NTA-Ni </a:t>
            </a:r>
            <a:r>
              <a:rPr lang="en-GB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posomes incubated with HR1-His peptides. Wells D, E and F contain the corresponding floated samples.  </a:t>
            </a:r>
            <a:endParaRPr lang="fr-FR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1090863" y="3535613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1950720" y="3535613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810577" y="3535613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670434" y="3535612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4530291" y="3535612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5390150" y="3535611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178777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3</TotalTime>
  <Words>56</Words>
  <Application>Microsoft Office PowerPoint</Application>
  <PresentationFormat>Grand écran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ais VLIEGHE</dc:creator>
  <cp:lastModifiedBy>David Tareste</cp:lastModifiedBy>
  <cp:revision>41</cp:revision>
  <dcterms:created xsi:type="dcterms:W3CDTF">2023-08-01T09:01:08Z</dcterms:created>
  <dcterms:modified xsi:type="dcterms:W3CDTF">2023-08-02T09:08:24Z</dcterms:modified>
</cp:coreProperties>
</file>